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43"/>
    <p:restoredTop sz="96405"/>
  </p:normalViewPr>
  <p:slideViewPr>
    <p:cSldViewPr snapToGrid="0" snapToObjects="1">
      <p:cViewPr>
        <p:scale>
          <a:sx n="165" d="100"/>
          <a:sy n="165" d="100"/>
        </p:scale>
        <p:origin x="128" y="-1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FE4D40-5227-651C-A7A6-E5BCF52476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56541E5-F9CD-AB67-BEE7-B934BA3AB7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62CC080-240E-B63B-C90C-258FCF8A3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7A63FF3-2133-C4C5-E871-8D1F1D5FB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0C6F31-7A1D-FF42-A3FC-FAF205646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0273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074A9AC-E7F9-C85B-A102-A797D67BC7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01BC924-80EA-D551-5E2D-F0442A50BD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33F9F0-7E96-A41C-DE77-6B05C4DC0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CC0864E-4619-DBB1-8456-23BE49B2B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85CD418-8D79-D58C-186C-2065B2689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8252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4EF90D0-49E6-79A3-A7CE-C0AB477D0A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F245C19-AA5D-C494-FEA6-2D05702DD6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1C2650B-3D4D-7A03-A73B-75C1AC2A2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0A9CE5-DB6D-A809-BE9E-3E5480E68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8BBF736-254E-D3D8-9252-FDA73E88E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4227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6CA8EE-D712-5460-619D-53836FF3A7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443322A-CA03-2BDE-0C70-573AC73438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BDCB95-D338-2B0B-F898-B46CE2B04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C66D60-3D02-8D6E-B3A2-BC88B308C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7C1EEC-7727-B957-142F-2F02913D0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9911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794049-C8C3-21BC-D9DA-F020082FC4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0C5EA54-87A3-7297-94E9-E462B9D3A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5A5370D-17EB-C930-9EC8-4150D998A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4F1B4D5-1AD3-6E35-A92E-26E1FF395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919641D-C9E6-5341-A3AB-53B5ED81F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65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BFBF7F6-6D0C-AD30-A136-02845BF821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16E8B41-C396-371E-BCBF-12F3F854B7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71016AE-97AC-1DB7-D4F1-E098CBC4F5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57AE9A5-1E24-57BF-6617-212E9A84B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8089E77-1E16-643A-1234-3772E2ABE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C2586C3-EC9D-E544-AB98-36DDD919C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957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B7785F1-8353-F99D-F319-7BAC19AF82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8DA16A8-7498-F3C9-8673-FE309D1FB1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EAAB418-8CCC-3AC4-6549-C55E16220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7F66E45-4167-D13C-C070-C28F8C81F4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5D2D06C-E829-1C87-58B4-B1CC6B9237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7A5222A-9B76-47DB-A1E1-98F726891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7E45C35-63DD-F226-D2C7-51F99F313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03E82D2-3DC7-F214-C11E-2B0B56A1D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6388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D7B933-04AC-C084-8B1B-D94899A238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AA59882-CB5D-D858-6E9B-50A4A5171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24A099C-FCD6-15E7-26E8-5AE15A7FF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28A6D58-13D0-19F2-4BE6-458260F84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511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EC4E150-4D68-4A24-5DC9-3DD0BC284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BA3D5E4-EE5D-A864-5B9E-8B8701A36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DE44CAC-3983-CE6F-63E1-EDCDBFEAE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8499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B0EE65-6F4D-3AAC-943A-DB48DD409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B301BFC-F511-4C36-6CD1-43728BF85F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9216430-736F-9CBC-C2C7-4614915105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8789E11-ABDE-27D3-B428-96F95C789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39B007C-AF25-E328-27A8-7098AC318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C0D284F-060C-1DFE-A237-314C80E94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498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96D03B-4652-436C-7CA8-932949D51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BF87114-B767-DBDD-9A9C-501D845BAD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89AFF69-DD5F-1659-7549-196968DD5C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07D8D50-8A21-6979-BF27-4F5C34550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80D1F27-A1C9-FA59-E157-1C223C13A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81B52C-D8A1-7F99-DAA2-8ED2C6049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3979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C10655E-3EBB-1B92-ED01-12C406C53D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91D676F-8645-1E31-E1A2-1049EA1E1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606CB74-4F9D-149D-F732-EBF775E39F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F886C-4E5C-A240-9FEA-5E06786150DA}" type="datetimeFigureOut">
              <a:rPr lang="fr-FR" smtClean="0"/>
              <a:t>19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54B768-D159-AE6B-DB37-3CAB0A0E38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959333-3905-7CAB-43F5-D5D3620503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E56EA-C906-EE45-9132-C438FE1B1E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1147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1526490" y="-27572"/>
            <a:ext cx="9141510" cy="1111361"/>
          </a:xfrm>
          <a:prstGeom prst="rect">
            <a:avLst/>
          </a:prstGeom>
          <a:solidFill>
            <a:schemeClr val="bg1">
              <a:lumMod val="95000"/>
              <a:alpha val="76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ZoneTexte 13"/>
          <p:cNvSpPr txBox="1"/>
          <p:nvPr/>
        </p:nvSpPr>
        <p:spPr>
          <a:xfrm>
            <a:off x="2566799" y="424827"/>
            <a:ext cx="70717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400" b="1">
                <a:latin typeface="Calibri"/>
                <a:cs typeface="Calibri"/>
              </a:rPr>
              <a:t>tRNA Northern 2344 (ARG.05)</a:t>
            </a:r>
          </a:p>
        </p:txBody>
      </p:sp>
      <p:grpSp>
        <p:nvGrpSpPr>
          <p:cNvPr id="15" name="Grouper 14"/>
          <p:cNvGrpSpPr>
            <a:grpSpLocks noChangeAspect="1"/>
          </p:cNvGrpSpPr>
          <p:nvPr/>
        </p:nvGrpSpPr>
        <p:grpSpPr>
          <a:xfrm>
            <a:off x="8233308" y="2285260"/>
            <a:ext cx="1153342" cy="216354"/>
            <a:chOff x="3229636" y="2827093"/>
            <a:chExt cx="961433" cy="180354"/>
          </a:xfrm>
        </p:grpSpPr>
        <p:cxnSp>
          <p:nvCxnSpPr>
            <p:cNvPr id="16" name="Connecteur droit 15"/>
            <p:cNvCxnSpPr/>
            <p:nvPr/>
          </p:nvCxnSpPr>
          <p:spPr>
            <a:xfrm>
              <a:off x="3229636" y="2912096"/>
              <a:ext cx="961433" cy="0"/>
            </a:xfrm>
            <a:prstGeom prst="line">
              <a:avLst/>
            </a:prstGeom>
            <a:ln w="38100" cmpd="sng">
              <a:solidFill>
                <a:schemeClr val="tx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tangle 16"/>
            <p:cNvSpPr/>
            <p:nvPr/>
          </p:nvSpPr>
          <p:spPr>
            <a:xfrm>
              <a:off x="3349276" y="2829005"/>
              <a:ext cx="287167" cy="178442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739280" y="2827093"/>
              <a:ext cx="287167" cy="178442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9" name="Grouper 18"/>
          <p:cNvGrpSpPr>
            <a:grpSpLocks noChangeAspect="1"/>
          </p:cNvGrpSpPr>
          <p:nvPr/>
        </p:nvGrpSpPr>
        <p:grpSpPr>
          <a:xfrm>
            <a:off x="8379549" y="2941541"/>
            <a:ext cx="1007513" cy="216354"/>
            <a:chOff x="3346949" y="3368571"/>
            <a:chExt cx="839869" cy="180354"/>
          </a:xfrm>
        </p:grpSpPr>
        <p:cxnSp>
          <p:nvCxnSpPr>
            <p:cNvPr id="20" name="Connecteur droit 19"/>
            <p:cNvCxnSpPr/>
            <p:nvPr/>
          </p:nvCxnSpPr>
          <p:spPr>
            <a:xfrm>
              <a:off x="3358818" y="3454404"/>
              <a:ext cx="828000" cy="0"/>
            </a:xfrm>
            <a:prstGeom prst="line">
              <a:avLst/>
            </a:prstGeom>
            <a:ln w="38100" cmpd="sng">
              <a:solidFill>
                <a:schemeClr val="tx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ctangle 20"/>
            <p:cNvSpPr/>
            <p:nvPr/>
          </p:nvSpPr>
          <p:spPr>
            <a:xfrm>
              <a:off x="3346949" y="3370483"/>
              <a:ext cx="287167" cy="178442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3736953" y="3368571"/>
              <a:ext cx="287167" cy="178442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3" name="Grouper 22"/>
          <p:cNvGrpSpPr>
            <a:grpSpLocks noChangeAspect="1"/>
          </p:cNvGrpSpPr>
          <p:nvPr/>
        </p:nvGrpSpPr>
        <p:grpSpPr>
          <a:xfrm>
            <a:off x="8381876" y="3266762"/>
            <a:ext cx="812339" cy="216354"/>
            <a:chOff x="3349276" y="3617592"/>
            <a:chExt cx="677171" cy="180354"/>
          </a:xfrm>
        </p:grpSpPr>
        <p:cxnSp>
          <p:nvCxnSpPr>
            <p:cNvPr id="24" name="Connecteur droit 23"/>
            <p:cNvCxnSpPr/>
            <p:nvPr/>
          </p:nvCxnSpPr>
          <p:spPr>
            <a:xfrm>
              <a:off x="3361146" y="3703425"/>
              <a:ext cx="611999" cy="0"/>
            </a:xfrm>
            <a:prstGeom prst="line">
              <a:avLst/>
            </a:prstGeom>
            <a:ln w="38100" cmpd="sng">
              <a:solidFill>
                <a:schemeClr val="tx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Rectangle 24"/>
            <p:cNvSpPr/>
            <p:nvPr/>
          </p:nvSpPr>
          <p:spPr>
            <a:xfrm>
              <a:off x="3349276" y="3619504"/>
              <a:ext cx="287167" cy="178442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739280" y="3617592"/>
              <a:ext cx="287167" cy="178442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7" name="Rectangle 26"/>
          <p:cNvSpPr/>
          <p:nvPr/>
        </p:nvSpPr>
        <p:spPr>
          <a:xfrm>
            <a:off x="8462690" y="5026494"/>
            <a:ext cx="358783" cy="213488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Rectangle 27"/>
          <p:cNvSpPr/>
          <p:nvPr/>
        </p:nvSpPr>
        <p:spPr>
          <a:xfrm>
            <a:off x="8831314" y="5026494"/>
            <a:ext cx="358783" cy="213488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9" name="Connecteur droit avec flèche 28"/>
          <p:cNvCxnSpPr/>
          <p:nvPr/>
        </p:nvCxnSpPr>
        <p:spPr>
          <a:xfrm>
            <a:off x="8811632" y="3891392"/>
            <a:ext cx="9841" cy="775578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avec flèche 30"/>
          <p:cNvCxnSpPr/>
          <p:nvPr/>
        </p:nvCxnSpPr>
        <p:spPr>
          <a:xfrm>
            <a:off x="8788339" y="2635735"/>
            <a:ext cx="0" cy="23427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>
            <a:off x="7680517" y="5178971"/>
            <a:ext cx="401191" cy="0"/>
          </a:xfrm>
          <a:prstGeom prst="straightConnector1">
            <a:avLst/>
          </a:prstGeom>
          <a:ln w="38100" cmpd="sng">
            <a:solidFill>
              <a:schemeClr val="tx1">
                <a:lumMod val="65000"/>
                <a:lumOff val="35000"/>
              </a:schemeClr>
            </a:solidFill>
            <a:prstDash val="sysDash"/>
            <a:headEnd type="oval"/>
            <a:tailEnd type="oval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avec flèche 32"/>
          <p:cNvCxnSpPr/>
          <p:nvPr/>
        </p:nvCxnSpPr>
        <p:spPr>
          <a:xfrm>
            <a:off x="7643852" y="3363244"/>
            <a:ext cx="428014" cy="0"/>
          </a:xfrm>
          <a:prstGeom prst="straightConnector1">
            <a:avLst/>
          </a:prstGeom>
          <a:ln w="38100" cmpd="sng">
            <a:solidFill>
              <a:schemeClr val="tx1">
                <a:lumMod val="65000"/>
                <a:lumOff val="35000"/>
              </a:schemeClr>
            </a:solidFill>
            <a:prstDash val="sysDash"/>
            <a:headEnd type="oval"/>
            <a:tailEnd type="oval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avec flèche 33"/>
          <p:cNvCxnSpPr/>
          <p:nvPr/>
        </p:nvCxnSpPr>
        <p:spPr>
          <a:xfrm flipV="1">
            <a:off x="7643852" y="3044507"/>
            <a:ext cx="428014" cy="2458"/>
          </a:xfrm>
          <a:prstGeom prst="straightConnector1">
            <a:avLst/>
          </a:prstGeom>
          <a:ln w="38100" cmpd="sng">
            <a:solidFill>
              <a:schemeClr val="tx1">
                <a:lumMod val="65000"/>
                <a:lumOff val="35000"/>
              </a:schemeClr>
            </a:solidFill>
            <a:prstDash val="sysDash"/>
            <a:headEnd type="oval"/>
            <a:tailEnd type="oval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/>
          <p:nvPr/>
        </p:nvCxnSpPr>
        <p:spPr>
          <a:xfrm>
            <a:off x="7643852" y="2392904"/>
            <a:ext cx="428014" cy="0"/>
          </a:xfrm>
          <a:prstGeom prst="straightConnector1">
            <a:avLst/>
          </a:prstGeom>
          <a:ln w="38100" cmpd="sng">
            <a:solidFill>
              <a:schemeClr val="tx1">
                <a:lumMod val="65000"/>
                <a:lumOff val="35000"/>
              </a:schemeClr>
            </a:solidFill>
            <a:prstDash val="sysDash"/>
            <a:headEnd type="oval"/>
            <a:tailEnd type="oval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ZoneTexte 35"/>
          <p:cNvSpPr txBox="1"/>
          <p:nvPr/>
        </p:nvSpPr>
        <p:spPr>
          <a:xfrm>
            <a:off x="1869410" y="6205963"/>
            <a:ext cx="6468767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>
                <a:latin typeface="Calibri"/>
                <a:cs typeface="Calibri"/>
              </a:rPr>
              <a:t>tRNA Northern-blot </a:t>
            </a:r>
            <a:r>
              <a:rPr lang="fr-FR" sz="1600">
                <a:latin typeface="Calibri"/>
                <a:cs typeface="Calibri"/>
              </a:rPr>
              <a:t>(ARG.05) : 8 ug total RNA (extracts from 12.06.2017), migration 4°C O/N, expo O/N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9465587" y="5026494"/>
            <a:ext cx="1024548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i="1">
                <a:latin typeface="Calibri"/>
                <a:cs typeface="Calibri"/>
              </a:rPr>
              <a:t>mature tRNA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9440044" y="2190497"/>
            <a:ext cx="2417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i="1">
                <a:latin typeface="Calibri"/>
                <a:cs typeface="Calibri"/>
              </a:rPr>
              <a:t>pre-tRNA</a:t>
            </a:r>
          </a:p>
        </p:txBody>
      </p:sp>
      <p:sp>
        <p:nvSpPr>
          <p:cNvPr id="52" name="ZoneTexte 51"/>
          <p:cNvSpPr txBox="1"/>
          <p:nvPr/>
        </p:nvSpPr>
        <p:spPr>
          <a:xfrm>
            <a:off x="2146299" y="1690661"/>
            <a:ext cx="4910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94      1635    552    1606   581    1861    780   1862</a:t>
            </a:r>
            <a:endParaRPr lang="fr-FR" i="1" dirty="0"/>
          </a:p>
        </p:txBody>
      </p:sp>
      <p:pic>
        <p:nvPicPr>
          <p:cNvPr id="53" name="Image 52" descr="ARG05_lsk1_rrp6_S2A 2017.06.23_08.57.59_Co.tif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282" t="41985" r="15191" b="30284"/>
          <a:stretch/>
        </p:blipFill>
        <p:spPr>
          <a:xfrm>
            <a:off x="1921236" y="2034154"/>
            <a:ext cx="5393964" cy="4152718"/>
          </a:xfrm>
          <a:prstGeom prst="rect">
            <a:avLst/>
          </a:prstGeom>
        </p:spPr>
      </p:pic>
      <p:cxnSp>
        <p:nvCxnSpPr>
          <p:cNvPr id="57" name="Connecteur droit 56"/>
          <p:cNvCxnSpPr/>
          <p:nvPr/>
        </p:nvCxnSpPr>
        <p:spPr>
          <a:xfrm>
            <a:off x="2185800" y="1615992"/>
            <a:ext cx="108000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ZoneTexte 57"/>
          <p:cNvSpPr txBox="1"/>
          <p:nvPr/>
        </p:nvSpPr>
        <p:spPr>
          <a:xfrm>
            <a:off x="2422964" y="1331072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i="1"/>
              <a:t>WT</a:t>
            </a:r>
          </a:p>
        </p:txBody>
      </p:sp>
      <p:cxnSp>
        <p:nvCxnSpPr>
          <p:cNvPr id="62" name="Connecteur droit 61"/>
          <p:cNvCxnSpPr/>
          <p:nvPr/>
        </p:nvCxnSpPr>
        <p:spPr>
          <a:xfrm>
            <a:off x="3375240" y="1615992"/>
            <a:ext cx="108000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/>
          <p:nvPr/>
        </p:nvSpPr>
        <p:spPr>
          <a:xfrm>
            <a:off x="3612404" y="1331072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i="1"/>
              <a:t>S2A</a:t>
            </a:r>
          </a:p>
        </p:txBody>
      </p:sp>
      <p:cxnSp>
        <p:nvCxnSpPr>
          <p:cNvPr id="64" name="Connecteur droit 63"/>
          <p:cNvCxnSpPr/>
          <p:nvPr/>
        </p:nvCxnSpPr>
        <p:spPr>
          <a:xfrm>
            <a:off x="4540450" y="1615992"/>
            <a:ext cx="108000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ZoneTexte 64"/>
          <p:cNvSpPr txBox="1"/>
          <p:nvPr/>
        </p:nvSpPr>
        <p:spPr>
          <a:xfrm>
            <a:off x="4777614" y="1331071"/>
            <a:ext cx="6056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/>
              <a:t>∆</a:t>
            </a:r>
            <a:r>
              <a:rPr lang="fr-FR" sz="1400" i="1"/>
              <a:t>lsk1</a:t>
            </a:r>
          </a:p>
          <a:p>
            <a:pPr algn="ctr"/>
            <a:endParaRPr lang="fr-FR" sz="1400" b="1"/>
          </a:p>
        </p:txBody>
      </p:sp>
      <p:cxnSp>
        <p:nvCxnSpPr>
          <p:cNvPr id="66" name="Connecteur droit 65"/>
          <p:cNvCxnSpPr/>
          <p:nvPr/>
        </p:nvCxnSpPr>
        <p:spPr>
          <a:xfrm>
            <a:off x="5767558" y="1615992"/>
            <a:ext cx="108000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ZoneTexte 66"/>
          <p:cNvSpPr txBox="1"/>
          <p:nvPr/>
        </p:nvSpPr>
        <p:spPr>
          <a:xfrm>
            <a:off x="6004722" y="1331072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/>
              <a:t>∆</a:t>
            </a:r>
            <a:r>
              <a:rPr lang="fr-FR" sz="1400" i="1"/>
              <a:t>rrp6</a:t>
            </a:r>
          </a:p>
        </p:txBody>
      </p:sp>
      <p:sp>
        <p:nvSpPr>
          <p:cNvPr id="68" name="ZoneTexte 67"/>
          <p:cNvSpPr txBox="1"/>
          <p:nvPr/>
        </p:nvSpPr>
        <p:spPr>
          <a:xfrm>
            <a:off x="6336832" y="1585803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i="1"/>
              <a:t>*</a:t>
            </a:r>
          </a:p>
        </p:txBody>
      </p:sp>
      <p:sp>
        <p:nvSpPr>
          <p:cNvPr id="69" name="ZoneTexte 68"/>
          <p:cNvSpPr txBox="1"/>
          <p:nvPr/>
        </p:nvSpPr>
        <p:spPr>
          <a:xfrm>
            <a:off x="3923124" y="1600646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i="1"/>
              <a:t>*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5097606" y="1603896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i="1"/>
              <a:t>*</a:t>
            </a:r>
          </a:p>
        </p:txBody>
      </p:sp>
      <p:sp>
        <p:nvSpPr>
          <p:cNvPr id="72" name="ZoneTexte 71"/>
          <p:cNvSpPr txBox="1"/>
          <p:nvPr/>
        </p:nvSpPr>
        <p:spPr>
          <a:xfrm>
            <a:off x="9465587" y="1083790"/>
            <a:ext cx="1202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i="1"/>
              <a:t>*  rpc25-flag</a:t>
            </a:r>
          </a:p>
        </p:txBody>
      </p:sp>
      <p:sp>
        <p:nvSpPr>
          <p:cNvPr id="73" name="ZoneTexte 72"/>
          <p:cNvSpPr txBox="1"/>
          <p:nvPr/>
        </p:nvSpPr>
        <p:spPr>
          <a:xfrm>
            <a:off x="2711306" y="1600646"/>
            <a:ext cx="605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i="1"/>
              <a:t>*</a:t>
            </a:r>
          </a:p>
        </p:txBody>
      </p:sp>
      <p:sp>
        <p:nvSpPr>
          <p:cNvPr id="74" name="ZoneTexte 73"/>
          <p:cNvSpPr txBox="1"/>
          <p:nvPr/>
        </p:nvSpPr>
        <p:spPr>
          <a:xfrm>
            <a:off x="6794202" y="-27572"/>
            <a:ext cx="53084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400" b="1">
                <a:latin typeface="Calibri"/>
                <a:cs typeface="Calibri"/>
              </a:rPr>
              <a:t>19/06/2017</a:t>
            </a:r>
          </a:p>
        </p:txBody>
      </p:sp>
    </p:spTree>
    <p:extLst>
      <p:ext uri="{BB962C8B-B14F-4D97-AF65-F5344CB8AC3E}">
        <p14:creationId xmlns:p14="http://schemas.microsoft.com/office/powerpoint/2010/main" val="398705665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61</Words>
  <Application>Microsoft Macintosh PowerPoint</Application>
  <PresentationFormat>Grand écran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4</cp:revision>
  <dcterms:created xsi:type="dcterms:W3CDTF">2022-07-19T07:37:59Z</dcterms:created>
  <dcterms:modified xsi:type="dcterms:W3CDTF">2022-07-19T08:37:52Z</dcterms:modified>
</cp:coreProperties>
</file>